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sldIdLst>
    <p:sldId id="258" r:id="rId2"/>
  </p:sldIdLst>
  <p:sldSz cx="9720263" cy="14400213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322" autoAdjust="0"/>
    <p:restoredTop sz="94660"/>
  </p:normalViewPr>
  <p:slideViewPr>
    <p:cSldViewPr snapToGrid="0">
      <p:cViewPr>
        <p:scale>
          <a:sx n="100" d="100"/>
          <a:sy n="100" d="100"/>
        </p:scale>
        <p:origin x="2268" y="-40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9020" y="2356703"/>
            <a:ext cx="8262224" cy="5013407"/>
          </a:xfrm>
        </p:spPr>
        <p:txBody>
          <a:bodyPr anchor="b"/>
          <a:lstStyle>
            <a:lvl1pPr algn="ctr">
              <a:defRPr sz="637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5033" y="7563446"/>
            <a:ext cx="7290197" cy="3476717"/>
          </a:xfrm>
        </p:spPr>
        <p:txBody>
          <a:bodyPr/>
          <a:lstStyle>
            <a:lvl1pPr marL="0" indent="0" algn="ctr">
              <a:buNone/>
              <a:defRPr sz="2551"/>
            </a:lvl1pPr>
            <a:lvl2pPr marL="486004" indent="0" algn="ctr">
              <a:buNone/>
              <a:defRPr sz="2126"/>
            </a:lvl2pPr>
            <a:lvl3pPr marL="972007" indent="0" algn="ctr">
              <a:buNone/>
              <a:defRPr sz="1913"/>
            </a:lvl3pPr>
            <a:lvl4pPr marL="1458011" indent="0" algn="ctr">
              <a:buNone/>
              <a:defRPr sz="1701"/>
            </a:lvl4pPr>
            <a:lvl5pPr marL="1944014" indent="0" algn="ctr">
              <a:buNone/>
              <a:defRPr sz="1701"/>
            </a:lvl5pPr>
            <a:lvl6pPr marL="2430018" indent="0" algn="ctr">
              <a:buNone/>
              <a:defRPr sz="1701"/>
            </a:lvl6pPr>
            <a:lvl7pPr marL="2916022" indent="0" algn="ctr">
              <a:buNone/>
              <a:defRPr sz="1701"/>
            </a:lvl7pPr>
            <a:lvl8pPr marL="3402025" indent="0" algn="ctr">
              <a:buNone/>
              <a:defRPr sz="1701"/>
            </a:lvl8pPr>
            <a:lvl9pPr marL="3888029" indent="0" algn="ctr">
              <a:buNone/>
              <a:defRPr sz="170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1508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5646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956064" y="766678"/>
            <a:ext cx="2095932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8269" y="766678"/>
            <a:ext cx="6166292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54601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0720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3206" y="3590057"/>
            <a:ext cx="8383727" cy="5990088"/>
          </a:xfrm>
        </p:spPr>
        <p:txBody>
          <a:bodyPr anchor="b"/>
          <a:lstStyle>
            <a:lvl1pPr>
              <a:defRPr sz="637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3206" y="9636813"/>
            <a:ext cx="8383727" cy="3150046"/>
          </a:xfrm>
        </p:spPr>
        <p:txBody>
          <a:bodyPr/>
          <a:lstStyle>
            <a:lvl1pPr marL="0" indent="0">
              <a:buNone/>
              <a:defRPr sz="2551">
                <a:solidFill>
                  <a:schemeClr val="tx1"/>
                </a:solidFill>
              </a:defRPr>
            </a:lvl1pPr>
            <a:lvl2pPr marL="486004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2pPr>
            <a:lvl3pPr marL="972007" indent="0">
              <a:buNone/>
              <a:defRPr sz="1913">
                <a:solidFill>
                  <a:schemeClr val="tx1">
                    <a:tint val="75000"/>
                  </a:schemeClr>
                </a:solidFill>
              </a:defRPr>
            </a:lvl3pPr>
            <a:lvl4pPr marL="1458011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4pPr>
            <a:lvl5pPr marL="1944014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5pPr>
            <a:lvl6pPr marL="2430018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6pPr>
            <a:lvl7pPr marL="2916022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7pPr>
            <a:lvl8pPr marL="3402025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8pPr>
            <a:lvl9pPr marL="3888029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438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8268" y="3833390"/>
            <a:ext cx="4131112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20883" y="3833390"/>
            <a:ext cx="4131112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8974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9534" y="766681"/>
            <a:ext cx="8383727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9535" y="3530053"/>
            <a:ext cx="4112126" cy="1730025"/>
          </a:xfrm>
        </p:spPr>
        <p:txBody>
          <a:bodyPr anchor="b"/>
          <a:lstStyle>
            <a:lvl1pPr marL="0" indent="0">
              <a:buNone/>
              <a:defRPr sz="2551" b="1"/>
            </a:lvl1pPr>
            <a:lvl2pPr marL="486004" indent="0">
              <a:buNone/>
              <a:defRPr sz="2126" b="1"/>
            </a:lvl2pPr>
            <a:lvl3pPr marL="972007" indent="0">
              <a:buNone/>
              <a:defRPr sz="1913" b="1"/>
            </a:lvl3pPr>
            <a:lvl4pPr marL="1458011" indent="0">
              <a:buNone/>
              <a:defRPr sz="1701" b="1"/>
            </a:lvl4pPr>
            <a:lvl5pPr marL="1944014" indent="0">
              <a:buNone/>
              <a:defRPr sz="1701" b="1"/>
            </a:lvl5pPr>
            <a:lvl6pPr marL="2430018" indent="0">
              <a:buNone/>
              <a:defRPr sz="1701" b="1"/>
            </a:lvl6pPr>
            <a:lvl7pPr marL="2916022" indent="0">
              <a:buNone/>
              <a:defRPr sz="1701" b="1"/>
            </a:lvl7pPr>
            <a:lvl8pPr marL="3402025" indent="0">
              <a:buNone/>
              <a:defRPr sz="1701" b="1"/>
            </a:lvl8pPr>
            <a:lvl9pPr marL="3888029" indent="0">
              <a:buNone/>
              <a:defRPr sz="170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9535" y="5260078"/>
            <a:ext cx="4112126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920884" y="3530053"/>
            <a:ext cx="4132378" cy="1730025"/>
          </a:xfrm>
        </p:spPr>
        <p:txBody>
          <a:bodyPr anchor="b"/>
          <a:lstStyle>
            <a:lvl1pPr marL="0" indent="0">
              <a:buNone/>
              <a:defRPr sz="2551" b="1"/>
            </a:lvl1pPr>
            <a:lvl2pPr marL="486004" indent="0">
              <a:buNone/>
              <a:defRPr sz="2126" b="1"/>
            </a:lvl2pPr>
            <a:lvl3pPr marL="972007" indent="0">
              <a:buNone/>
              <a:defRPr sz="1913" b="1"/>
            </a:lvl3pPr>
            <a:lvl4pPr marL="1458011" indent="0">
              <a:buNone/>
              <a:defRPr sz="1701" b="1"/>
            </a:lvl4pPr>
            <a:lvl5pPr marL="1944014" indent="0">
              <a:buNone/>
              <a:defRPr sz="1701" b="1"/>
            </a:lvl5pPr>
            <a:lvl6pPr marL="2430018" indent="0">
              <a:buNone/>
              <a:defRPr sz="1701" b="1"/>
            </a:lvl6pPr>
            <a:lvl7pPr marL="2916022" indent="0">
              <a:buNone/>
              <a:defRPr sz="1701" b="1"/>
            </a:lvl7pPr>
            <a:lvl8pPr marL="3402025" indent="0">
              <a:buNone/>
              <a:defRPr sz="1701" b="1"/>
            </a:lvl8pPr>
            <a:lvl9pPr marL="3888029" indent="0">
              <a:buNone/>
              <a:defRPr sz="170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920884" y="5260078"/>
            <a:ext cx="4132378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1185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6014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5725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9534" y="960014"/>
            <a:ext cx="3135038" cy="3360050"/>
          </a:xfrm>
        </p:spPr>
        <p:txBody>
          <a:bodyPr anchor="b"/>
          <a:lstStyle>
            <a:lvl1pPr>
              <a:defRPr sz="340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32378" y="2073367"/>
            <a:ext cx="4920883" cy="10233485"/>
          </a:xfrm>
        </p:spPr>
        <p:txBody>
          <a:bodyPr/>
          <a:lstStyle>
            <a:lvl1pPr>
              <a:defRPr sz="3402"/>
            </a:lvl1pPr>
            <a:lvl2pPr>
              <a:defRPr sz="2976"/>
            </a:lvl2pPr>
            <a:lvl3pPr>
              <a:defRPr sz="2551"/>
            </a:lvl3pPr>
            <a:lvl4pPr>
              <a:defRPr sz="2126"/>
            </a:lvl4pPr>
            <a:lvl5pPr>
              <a:defRPr sz="2126"/>
            </a:lvl5pPr>
            <a:lvl6pPr>
              <a:defRPr sz="2126"/>
            </a:lvl6pPr>
            <a:lvl7pPr>
              <a:defRPr sz="2126"/>
            </a:lvl7pPr>
            <a:lvl8pPr>
              <a:defRPr sz="2126"/>
            </a:lvl8pPr>
            <a:lvl9pPr>
              <a:defRPr sz="212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9534" y="4320064"/>
            <a:ext cx="3135038" cy="8003453"/>
          </a:xfrm>
        </p:spPr>
        <p:txBody>
          <a:bodyPr/>
          <a:lstStyle>
            <a:lvl1pPr marL="0" indent="0">
              <a:buNone/>
              <a:defRPr sz="1701"/>
            </a:lvl1pPr>
            <a:lvl2pPr marL="486004" indent="0">
              <a:buNone/>
              <a:defRPr sz="1488"/>
            </a:lvl2pPr>
            <a:lvl3pPr marL="972007" indent="0">
              <a:buNone/>
              <a:defRPr sz="1276"/>
            </a:lvl3pPr>
            <a:lvl4pPr marL="1458011" indent="0">
              <a:buNone/>
              <a:defRPr sz="1063"/>
            </a:lvl4pPr>
            <a:lvl5pPr marL="1944014" indent="0">
              <a:buNone/>
              <a:defRPr sz="1063"/>
            </a:lvl5pPr>
            <a:lvl6pPr marL="2430018" indent="0">
              <a:buNone/>
              <a:defRPr sz="1063"/>
            </a:lvl6pPr>
            <a:lvl7pPr marL="2916022" indent="0">
              <a:buNone/>
              <a:defRPr sz="1063"/>
            </a:lvl7pPr>
            <a:lvl8pPr marL="3402025" indent="0">
              <a:buNone/>
              <a:defRPr sz="1063"/>
            </a:lvl8pPr>
            <a:lvl9pPr marL="3888029" indent="0">
              <a:buNone/>
              <a:defRPr sz="10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7528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9534" y="960014"/>
            <a:ext cx="3135038" cy="3360050"/>
          </a:xfrm>
        </p:spPr>
        <p:txBody>
          <a:bodyPr anchor="b"/>
          <a:lstStyle>
            <a:lvl1pPr>
              <a:defRPr sz="340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132378" y="2073367"/>
            <a:ext cx="4920883" cy="10233485"/>
          </a:xfrm>
        </p:spPr>
        <p:txBody>
          <a:bodyPr anchor="t"/>
          <a:lstStyle>
            <a:lvl1pPr marL="0" indent="0">
              <a:buNone/>
              <a:defRPr sz="3402"/>
            </a:lvl1pPr>
            <a:lvl2pPr marL="486004" indent="0">
              <a:buNone/>
              <a:defRPr sz="2976"/>
            </a:lvl2pPr>
            <a:lvl3pPr marL="972007" indent="0">
              <a:buNone/>
              <a:defRPr sz="2551"/>
            </a:lvl3pPr>
            <a:lvl4pPr marL="1458011" indent="0">
              <a:buNone/>
              <a:defRPr sz="2126"/>
            </a:lvl4pPr>
            <a:lvl5pPr marL="1944014" indent="0">
              <a:buNone/>
              <a:defRPr sz="2126"/>
            </a:lvl5pPr>
            <a:lvl6pPr marL="2430018" indent="0">
              <a:buNone/>
              <a:defRPr sz="2126"/>
            </a:lvl6pPr>
            <a:lvl7pPr marL="2916022" indent="0">
              <a:buNone/>
              <a:defRPr sz="2126"/>
            </a:lvl7pPr>
            <a:lvl8pPr marL="3402025" indent="0">
              <a:buNone/>
              <a:defRPr sz="2126"/>
            </a:lvl8pPr>
            <a:lvl9pPr marL="3888029" indent="0">
              <a:buNone/>
              <a:defRPr sz="212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9534" y="4320064"/>
            <a:ext cx="3135038" cy="8003453"/>
          </a:xfrm>
        </p:spPr>
        <p:txBody>
          <a:bodyPr/>
          <a:lstStyle>
            <a:lvl1pPr marL="0" indent="0">
              <a:buNone/>
              <a:defRPr sz="1701"/>
            </a:lvl1pPr>
            <a:lvl2pPr marL="486004" indent="0">
              <a:buNone/>
              <a:defRPr sz="1488"/>
            </a:lvl2pPr>
            <a:lvl3pPr marL="972007" indent="0">
              <a:buNone/>
              <a:defRPr sz="1276"/>
            </a:lvl3pPr>
            <a:lvl4pPr marL="1458011" indent="0">
              <a:buNone/>
              <a:defRPr sz="1063"/>
            </a:lvl4pPr>
            <a:lvl5pPr marL="1944014" indent="0">
              <a:buNone/>
              <a:defRPr sz="1063"/>
            </a:lvl5pPr>
            <a:lvl6pPr marL="2430018" indent="0">
              <a:buNone/>
              <a:defRPr sz="1063"/>
            </a:lvl6pPr>
            <a:lvl7pPr marL="2916022" indent="0">
              <a:buNone/>
              <a:defRPr sz="1063"/>
            </a:lvl7pPr>
            <a:lvl8pPr marL="3402025" indent="0">
              <a:buNone/>
              <a:defRPr sz="1063"/>
            </a:lvl8pPr>
            <a:lvl9pPr marL="3888029" indent="0">
              <a:buNone/>
              <a:defRPr sz="10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54863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8268" y="766681"/>
            <a:ext cx="8383727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8268" y="3833390"/>
            <a:ext cx="8383727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8268" y="13346867"/>
            <a:ext cx="218705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959429-BEF9-4B39-8831-456C80403EBE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19837" y="13346867"/>
            <a:ext cx="328058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64936" y="13346867"/>
            <a:ext cx="218705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58143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972007" rtl="0" eaLnBrk="1" latinLnBrk="0" hangingPunct="1">
        <a:lnSpc>
          <a:spcPct val="90000"/>
        </a:lnSpc>
        <a:spcBef>
          <a:spcPct val="0"/>
        </a:spcBef>
        <a:buNone/>
        <a:defRPr sz="467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3002" indent="-243002" algn="l" defTabSz="972007" rtl="0" eaLnBrk="1" latinLnBrk="0" hangingPunct="1">
        <a:lnSpc>
          <a:spcPct val="90000"/>
        </a:lnSpc>
        <a:spcBef>
          <a:spcPts val="1063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1pPr>
      <a:lvl2pPr marL="729005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15009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701013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4pPr>
      <a:lvl5pPr marL="2187016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5pPr>
      <a:lvl6pPr marL="2673020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6pPr>
      <a:lvl7pPr marL="3159023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7pPr>
      <a:lvl8pPr marL="3645027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8pPr>
      <a:lvl9pPr marL="4131031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1pPr>
      <a:lvl2pPr marL="486004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2pPr>
      <a:lvl3pPr marL="972007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3pPr>
      <a:lvl4pPr marL="1458011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4pPr>
      <a:lvl5pPr marL="1944014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5pPr>
      <a:lvl6pPr marL="2430018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6pPr>
      <a:lvl7pPr marL="2916022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7pPr>
      <a:lvl8pPr marL="3402025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8pPr>
      <a:lvl9pPr marL="3888029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6" name="Table 17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2474243"/>
              </p:ext>
            </p:extLst>
          </p:nvPr>
        </p:nvGraphicFramePr>
        <p:xfrm>
          <a:off x="5101200" y="5400473"/>
          <a:ext cx="2992237" cy="2200275"/>
        </p:xfrm>
        <a:graphic>
          <a:graphicData uri="http://schemas.openxmlformats.org/drawingml/2006/table">
            <a:tbl>
              <a:tblPr>
                <a:tableStyleId>{6E25E649-3F16-4E02-A733-19D2CDBF48F0}</a:tableStyleId>
              </a:tblPr>
              <a:tblGrid>
                <a:gridCol w="655085">
                  <a:extLst>
                    <a:ext uri="{9D8B030D-6E8A-4147-A177-3AD203B41FA5}">
                      <a16:colId xmlns:a16="http://schemas.microsoft.com/office/drawing/2014/main" val="3694016379"/>
                    </a:ext>
                  </a:extLst>
                </a:gridCol>
                <a:gridCol w="1061633">
                  <a:extLst>
                    <a:ext uri="{9D8B030D-6E8A-4147-A177-3AD203B41FA5}">
                      <a16:colId xmlns:a16="http://schemas.microsoft.com/office/drawing/2014/main" val="362984103"/>
                    </a:ext>
                  </a:extLst>
                </a:gridCol>
                <a:gridCol w="1275519">
                  <a:extLst>
                    <a:ext uri="{9D8B030D-6E8A-4147-A177-3AD203B41FA5}">
                      <a16:colId xmlns:a16="http://schemas.microsoft.com/office/drawing/2014/main" val="2268012572"/>
                    </a:ext>
                  </a:extLst>
                </a:gridCol>
              </a:tblGrid>
              <a:tr h="400050">
                <a:tc>
                  <a:txBody>
                    <a:bodyPr/>
                    <a:lstStyle/>
                    <a:p>
                      <a:pPr algn="ctr" fontAlgn="ctr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reads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que </a:t>
                      </a:r>
                      <a:r>
                        <a:rPr lang="en-GB" sz="12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Y5</a:t>
                      </a:r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equence motifs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1432882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1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2,36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4145234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1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2,58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5634127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1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0,57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4598197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2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2,19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7562790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2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5,73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1657913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2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8,71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9057594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3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4,44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2131061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3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6,30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4873633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3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8,03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39359804"/>
                  </a:ext>
                </a:extLst>
              </a:tr>
            </a:tbl>
          </a:graphicData>
        </a:graphic>
      </p:graphicFrame>
      <p:graphicFrame>
        <p:nvGraphicFramePr>
          <p:cNvPr id="177" name="Table 17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7473286"/>
              </p:ext>
            </p:extLst>
          </p:nvPr>
        </p:nvGraphicFramePr>
        <p:xfrm>
          <a:off x="491789" y="7302974"/>
          <a:ext cx="2992236" cy="2182279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655085">
                  <a:extLst>
                    <a:ext uri="{9D8B030D-6E8A-4147-A177-3AD203B41FA5}">
                      <a16:colId xmlns:a16="http://schemas.microsoft.com/office/drawing/2014/main" val="3802237128"/>
                    </a:ext>
                  </a:extLst>
                </a:gridCol>
                <a:gridCol w="972391">
                  <a:extLst>
                    <a:ext uri="{9D8B030D-6E8A-4147-A177-3AD203B41FA5}">
                      <a16:colId xmlns:a16="http://schemas.microsoft.com/office/drawing/2014/main" val="268983453"/>
                    </a:ext>
                  </a:extLst>
                </a:gridCol>
                <a:gridCol w="1364760">
                  <a:extLst>
                    <a:ext uri="{9D8B030D-6E8A-4147-A177-3AD203B41FA5}">
                      <a16:colId xmlns:a16="http://schemas.microsoft.com/office/drawing/2014/main" val="94834909"/>
                    </a:ext>
                  </a:extLst>
                </a:gridCol>
              </a:tblGrid>
              <a:tr h="382054">
                <a:tc>
                  <a:txBody>
                    <a:bodyPr/>
                    <a:lstStyle/>
                    <a:p>
                      <a:pPr algn="ctr" fontAlgn="ctr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reads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</a:t>
                      </a:r>
                    </a:p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s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5355974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1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414,197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2354841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1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388,19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1486089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1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780,20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9797179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2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84,67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7893422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2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3,73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1100082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2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8,52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1767489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3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99,65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4 </a:t>
                      </a:r>
                      <a:r>
                        <a:rPr lang="en-GB" sz="120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0 missing)</a:t>
                      </a:r>
                      <a:endParaRPr lang="en-GB" sz="120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8912827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3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5,3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6 </a:t>
                      </a:r>
                      <a:r>
                        <a:rPr lang="en-GB" sz="120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18 missing)</a:t>
                      </a:r>
                      <a:endParaRPr lang="en-GB" sz="120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4909882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3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2,7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8 </a:t>
                      </a:r>
                      <a:r>
                        <a:rPr lang="en-GB" sz="120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6 missing)</a:t>
                      </a:r>
                      <a:endParaRPr lang="en-GB" sz="120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83380622"/>
                  </a:ext>
                </a:extLst>
              </a:tr>
            </a:tbl>
          </a:graphicData>
        </a:graphic>
      </p:graphicFrame>
      <p:sp>
        <p:nvSpPr>
          <p:cNvPr id="178" name="TextBox 177"/>
          <p:cNvSpPr txBox="1"/>
          <p:nvPr/>
        </p:nvSpPr>
        <p:spPr>
          <a:xfrm>
            <a:off x="4860131" y="4828475"/>
            <a:ext cx="241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81" name="Oval 103">
            <a:extLst>
              <a:ext uri="{FF2B5EF4-FFF2-40B4-BE49-F238E27FC236}">
                <a16:creationId xmlns:a16="http://schemas.microsoft.com/office/drawing/2014/main" id="{B5CF175B-EF3D-4C76-8FF4-DBA39073B7D0}"/>
              </a:ext>
            </a:extLst>
          </p:cNvPr>
          <p:cNvSpPr/>
          <p:nvPr/>
        </p:nvSpPr>
        <p:spPr>
          <a:xfrm>
            <a:off x="80879" y="1105046"/>
            <a:ext cx="5243669" cy="776284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82" name="TextBox 5">
            <a:extLst>
              <a:ext uri="{FF2B5EF4-FFF2-40B4-BE49-F238E27FC236}">
                <a16:creationId xmlns:a16="http://schemas.microsoft.com/office/drawing/2014/main" id="{999BB7EC-36B8-4EED-973A-E1A956D45898}"/>
              </a:ext>
            </a:extLst>
          </p:cNvPr>
          <p:cNvSpPr txBox="1"/>
          <p:nvPr/>
        </p:nvSpPr>
        <p:spPr>
          <a:xfrm>
            <a:off x="0" y="0"/>
            <a:ext cx="241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3" name="Rectangle 87">
            <a:extLst>
              <a:ext uri="{FF2B5EF4-FFF2-40B4-BE49-F238E27FC236}">
                <a16:creationId xmlns:a16="http://schemas.microsoft.com/office/drawing/2014/main" id="{7A0BB8D8-B72F-4796-BDA7-0DDA4C215AB2}"/>
              </a:ext>
            </a:extLst>
          </p:cNvPr>
          <p:cNvSpPr/>
          <p:nvPr/>
        </p:nvSpPr>
        <p:spPr>
          <a:xfrm>
            <a:off x="347016" y="1074319"/>
            <a:ext cx="1904134" cy="276999"/>
          </a:xfrm>
          <a:prstGeom prst="rect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84" name="TextBox 88">
            <a:extLst>
              <a:ext uri="{FF2B5EF4-FFF2-40B4-BE49-F238E27FC236}">
                <a16:creationId xmlns:a16="http://schemas.microsoft.com/office/drawing/2014/main" id="{CE2E06B5-CADC-4E15-A65F-CF04D7B480D3}"/>
              </a:ext>
            </a:extLst>
          </p:cNvPr>
          <p:cNvSpPr txBox="1"/>
          <p:nvPr/>
        </p:nvSpPr>
        <p:spPr>
          <a:xfrm>
            <a:off x="306245" y="1074110"/>
            <a:ext cx="1985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lanking seq (2.9 kb)</a:t>
            </a:r>
          </a:p>
        </p:txBody>
      </p:sp>
      <p:sp>
        <p:nvSpPr>
          <p:cNvPr id="85" name="Rectangle 90">
            <a:extLst>
              <a:ext uri="{FF2B5EF4-FFF2-40B4-BE49-F238E27FC236}">
                <a16:creationId xmlns:a16="http://schemas.microsoft.com/office/drawing/2014/main" id="{5927269D-7DC9-4937-A3E0-CF0742469E03}"/>
              </a:ext>
            </a:extLst>
          </p:cNvPr>
          <p:cNvSpPr/>
          <p:nvPr/>
        </p:nvSpPr>
        <p:spPr>
          <a:xfrm>
            <a:off x="2251164" y="1074215"/>
            <a:ext cx="1354197" cy="276999"/>
          </a:xfrm>
          <a:prstGeom prst="rect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86" name="TextBox 89">
            <a:extLst>
              <a:ext uri="{FF2B5EF4-FFF2-40B4-BE49-F238E27FC236}">
                <a16:creationId xmlns:a16="http://schemas.microsoft.com/office/drawing/2014/main" id="{997E8AF7-172D-40B6-9313-30E8B7476A9F}"/>
              </a:ext>
            </a:extLst>
          </p:cNvPr>
          <p:cNvSpPr txBox="1"/>
          <p:nvPr/>
        </p:nvSpPr>
        <p:spPr>
          <a:xfrm>
            <a:off x="2342512" y="1073901"/>
            <a:ext cx="11300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RNY5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(84 nt)</a:t>
            </a:r>
          </a:p>
        </p:txBody>
      </p:sp>
      <p:sp>
        <p:nvSpPr>
          <p:cNvPr id="87" name="Rectangle 93">
            <a:extLst>
              <a:ext uri="{FF2B5EF4-FFF2-40B4-BE49-F238E27FC236}">
                <a16:creationId xmlns:a16="http://schemas.microsoft.com/office/drawing/2014/main" id="{D033681A-45A9-49FE-A54B-A532AE97CCAD}"/>
              </a:ext>
            </a:extLst>
          </p:cNvPr>
          <p:cNvSpPr/>
          <p:nvPr/>
        </p:nvSpPr>
        <p:spPr>
          <a:xfrm>
            <a:off x="3604635" y="1073900"/>
            <a:ext cx="1447906" cy="276999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88" name="TextBox 92">
            <a:extLst>
              <a:ext uri="{FF2B5EF4-FFF2-40B4-BE49-F238E27FC236}">
                <a16:creationId xmlns:a16="http://schemas.microsoft.com/office/drawing/2014/main" id="{D6686916-CF1D-4756-BF19-B7C88346EF83}"/>
              </a:ext>
            </a:extLst>
          </p:cNvPr>
          <p:cNvSpPr txBox="1"/>
          <p:nvPr/>
        </p:nvSpPr>
        <p:spPr>
          <a:xfrm>
            <a:off x="3477355" y="1073901"/>
            <a:ext cx="1728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ownstream (30 nt)</a:t>
            </a:r>
          </a:p>
        </p:txBody>
      </p:sp>
      <p:sp>
        <p:nvSpPr>
          <p:cNvPr id="89" name="TextBox 95">
            <a:extLst>
              <a:ext uri="{FF2B5EF4-FFF2-40B4-BE49-F238E27FC236}">
                <a16:creationId xmlns:a16="http://schemas.microsoft.com/office/drawing/2014/main" id="{45A21EDB-BBC6-4903-ADB1-DC201E373DCE}"/>
              </a:ext>
            </a:extLst>
          </p:cNvPr>
          <p:cNvSpPr txBox="1"/>
          <p:nvPr/>
        </p:nvSpPr>
        <p:spPr>
          <a:xfrm>
            <a:off x="2291951" y="72571"/>
            <a:ext cx="19026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1        </a:t>
            </a:r>
            <a:r>
              <a:rPr lang="en-GB" sz="12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2         </a:t>
            </a:r>
            <a:r>
              <a:rPr lang="en-GB" sz="12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3</a:t>
            </a:r>
          </a:p>
          <a:p>
            <a:r>
              <a: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NNNN</a:t>
            </a:r>
            <a:r>
              <a:rPr lang="en-GB" sz="12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NNNN</a:t>
            </a:r>
            <a:r>
              <a:rPr lang="en-GB" sz="12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NNNN</a:t>
            </a:r>
          </a:p>
        </p:txBody>
      </p:sp>
      <p:cxnSp>
        <p:nvCxnSpPr>
          <p:cNvPr id="90" name="Straight Connector 98">
            <a:extLst>
              <a:ext uri="{FF2B5EF4-FFF2-40B4-BE49-F238E27FC236}">
                <a16:creationId xmlns:a16="http://schemas.microsoft.com/office/drawing/2014/main" id="{49F533E4-9801-40FF-9A78-BA546F3BB836}"/>
              </a:ext>
            </a:extLst>
          </p:cNvPr>
          <p:cNvCxnSpPr/>
          <p:nvPr/>
        </p:nvCxnSpPr>
        <p:spPr>
          <a:xfrm>
            <a:off x="2342512" y="571448"/>
            <a:ext cx="1017053" cy="449165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100">
            <a:extLst>
              <a:ext uri="{FF2B5EF4-FFF2-40B4-BE49-F238E27FC236}">
                <a16:creationId xmlns:a16="http://schemas.microsoft.com/office/drawing/2014/main" id="{75E827D8-347F-48BC-89C0-28A119D13273}"/>
              </a:ext>
            </a:extLst>
          </p:cNvPr>
          <p:cNvCxnSpPr/>
          <p:nvPr/>
        </p:nvCxnSpPr>
        <p:spPr>
          <a:xfrm flipH="1">
            <a:off x="3563859" y="526862"/>
            <a:ext cx="426415" cy="501745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Rectangle 104">
            <a:extLst>
              <a:ext uri="{FF2B5EF4-FFF2-40B4-BE49-F238E27FC236}">
                <a16:creationId xmlns:a16="http://schemas.microsoft.com/office/drawing/2014/main" id="{7B19A479-41DB-4999-A591-E3544477023D}"/>
              </a:ext>
            </a:extLst>
          </p:cNvPr>
          <p:cNvSpPr/>
          <p:nvPr/>
        </p:nvSpPr>
        <p:spPr>
          <a:xfrm>
            <a:off x="2039698" y="1464208"/>
            <a:ext cx="172810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GEMT-</a:t>
            </a:r>
            <a:r>
              <a:rPr lang="en-GB" sz="14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NY5</a:t>
            </a:r>
            <a:r>
              <a:rPr lang="en-GB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WT 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77">
            <a:extLst>
              <a:ext uri="{FF2B5EF4-FFF2-40B4-BE49-F238E27FC236}">
                <a16:creationId xmlns:a16="http://schemas.microsoft.com/office/drawing/2014/main" id="{EA24B9E8-A79B-4FBF-BA64-62CD21BD16B3}"/>
              </a:ext>
            </a:extLst>
          </p:cNvPr>
          <p:cNvSpPr txBox="1"/>
          <p:nvPr/>
        </p:nvSpPr>
        <p:spPr>
          <a:xfrm>
            <a:off x="0" y="6717808"/>
            <a:ext cx="241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" name="Rectangle 1"/>
          <p:cNvSpPr/>
          <p:nvPr/>
        </p:nvSpPr>
        <p:spPr>
          <a:xfrm>
            <a:off x="80879" y="9680681"/>
            <a:ext cx="9639384" cy="45713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GB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le 1. 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Full length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th 2.9 kb of 5’ flanking sequence plus 30 bp of downstream sequence into a pGEMT easy vector, which is required and sufficient to produce Y RNA transcripts from the plasmid. The mutations introduced by mutagenesis PCR using primers containing random nts are shown for mutant pool L1 (red), mutant pool 2 (green), mutant pool L3 (blue). (</a:t>
            </a:r>
            <a:r>
              <a:rPr lang="en-GB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GB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ample of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leavage fragment detection after staurosporine (STS) treatment. NIH/3T3 cells were cultured for 24 h before transfection with plasmid DNA using Fugene6. Then 24 h after transfection, cells were treated with water control or 1M STS for 4 h before RNA extraction and probing. Northern blot shows no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 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r fragments in the transfection reagent or empty vector controls. There is slight detection of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ragment in the plasmid containing wild type full length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quence. Only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no fragments were detected in the cleavage region deletion </a:t>
            </a:r>
            <a:r>
              <a:rPr lang="en-GB" sz="1050" dirty="0">
                <a:ea typeface="Calibri" panose="020F0502020204030204" pitchFamily="34" charset="0"/>
                <a:cs typeface="Times New Roman" panose="02020603050405020304" pitchFamily="18" charset="0"/>
              </a:rPr>
              <a:t>mutants (</a:t>
            </a:r>
            <a:r>
              <a:rPr lang="el-GR" sz="1050" dirty="0"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n-GB" sz="1050" dirty="0">
                <a:ea typeface="Calibri" panose="020F0502020204030204" pitchFamily="34" charset="0"/>
                <a:cs typeface="Arial" panose="020B0604020202020204" pitchFamily="34" charset="0"/>
              </a:rPr>
              <a:t>1 and</a:t>
            </a:r>
            <a:r>
              <a:rPr lang="el-GR" sz="1050" dirty="0">
                <a:ea typeface="Calibri" panose="020F0502020204030204" pitchFamily="34" charset="0"/>
                <a:cs typeface="Arial" panose="020B0604020202020204" pitchFamily="34" charset="0"/>
              </a:rPr>
              <a:t> Δ</a:t>
            </a:r>
            <a:r>
              <a:rPr lang="en-GB" sz="1050" dirty="0">
                <a:ea typeface="Calibri" panose="020F0502020204030204" pitchFamily="34" charset="0"/>
                <a:cs typeface="Arial" panose="020B0604020202020204" pitchFamily="34" charset="0"/>
              </a:rPr>
              <a:t>2). There was strong detection of </a:t>
            </a:r>
            <a:r>
              <a:rPr lang="en-GB" sz="1050" i="1" dirty="0">
                <a:ea typeface="Calibri" panose="020F0502020204030204" pitchFamily="34" charset="0"/>
                <a:cs typeface="Arial" panose="020B0604020202020204" pitchFamily="34" charset="0"/>
              </a:rPr>
              <a:t>RNY5</a:t>
            </a:r>
            <a:r>
              <a:rPr lang="en-GB" sz="1050" dirty="0">
                <a:ea typeface="Calibri" panose="020F0502020204030204" pitchFamily="34" charset="0"/>
                <a:cs typeface="Arial" panose="020B0604020202020204" pitchFamily="34" charset="0"/>
              </a:rPr>
              <a:t> fragment in the wild type plasmid when treated with STS. There was no </a:t>
            </a:r>
            <a:r>
              <a:rPr lang="en-GB" sz="1050" i="1" dirty="0">
                <a:ea typeface="Calibri" panose="020F0502020204030204" pitchFamily="34" charset="0"/>
                <a:cs typeface="Arial" panose="020B0604020202020204" pitchFamily="34" charset="0"/>
              </a:rPr>
              <a:t>RNY5</a:t>
            </a:r>
            <a:r>
              <a:rPr lang="en-GB" sz="1050" dirty="0">
                <a:ea typeface="Calibri" panose="020F0502020204030204" pitchFamily="34" charset="0"/>
                <a:cs typeface="Arial" panose="020B0604020202020204" pitchFamily="34" charset="0"/>
              </a:rPr>
              <a:t> fragment in the mutant plasmids when treated with STS. We performed this experiment several times using 2.5, 5 and 10 ug of plasmid DNA establishing our model where no Y RNA is detectable (neither full length or fragment) unless the cells are transfected with a Y RNA expressing plasmid and that in the absence of STS the level of Y RNA fragments are either not detectable or much lower than in the presence of STS. 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nts generate ysRNAs at the same size as wild type. Northern blot was probed with the 3’ and 5’ ysRNA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obe and U6 was used as loading control. As a positive control a MCF7 cell line treated with poly (I:C) and a synthetic 3’ end derived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ragment of 31 nt were used as size markers for full length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wild type-sized ysRNAs. (</a:t>
            </a:r>
            <a:r>
              <a:rPr lang="en-GB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Redundant reads for biological replicates of plasmid bias (PB) L1, L2 and L3 plus unique reads mapping to each possible full length mutant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(</a:t>
            </a:r>
            <a:r>
              <a:rPr lang="en-GB" sz="105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Redundant reads for biological replicates of full length (FL) L1, L2 and L3 plus unique reads mapping to each possible full length mutant </a:t>
            </a:r>
            <a:r>
              <a:rPr lang="en-GB" sz="105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05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In FL-L3 not all 1,024 unique mutant sequences were present (number of missing mutant sequences are shown in blue).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BBAD79ED-975A-4AEA-A34B-CC60EE809E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33958" y="2083651"/>
            <a:ext cx="2788707" cy="2360234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7B8E7B13-DFB0-4D71-90B7-CCDBC8AE1220}"/>
              </a:ext>
            </a:extLst>
          </p:cNvPr>
          <p:cNvSpPr txBox="1"/>
          <p:nvPr/>
        </p:nvSpPr>
        <p:spPr>
          <a:xfrm>
            <a:off x="4604920" y="4006618"/>
            <a:ext cx="14782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miR-19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FE016ED-6C7A-46FD-A029-38A6B0A84170}"/>
              </a:ext>
            </a:extLst>
          </p:cNvPr>
          <p:cNvSpPr txBox="1"/>
          <p:nvPr/>
        </p:nvSpPr>
        <p:spPr>
          <a:xfrm>
            <a:off x="4506546" y="3311274"/>
            <a:ext cx="15806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3’ </a:t>
            </a:r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RNY5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sRN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34A2CF0-A74F-47A4-9B31-6735A10A248E}"/>
              </a:ext>
            </a:extLst>
          </p:cNvPr>
          <p:cNvSpPr txBox="1"/>
          <p:nvPr/>
        </p:nvSpPr>
        <p:spPr>
          <a:xfrm>
            <a:off x="4213023" y="2610003"/>
            <a:ext cx="1858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ull length </a:t>
            </a:r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RNY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0BBDC3B-4882-4623-9DB4-23793D84A4F2}"/>
              </a:ext>
            </a:extLst>
          </p:cNvPr>
          <p:cNvSpPr txBox="1"/>
          <p:nvPr/>
        </p:nvSpPr>
        <p:spPr>
          <a:xfrm rot="18587907">
            <a:off x="5842985" y="1229097"/>
            <a:ext cx="1656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ugene control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D15477F-FAB4-4A0E-81FE-D36A785397F4}"/>
              </a:ext>
            </a:extLst>
          </p:cNvPr>
          <p:cNvSpPr txBox="1"/>
          <p:nvPr/>
        </p:nvSpPr>
        <p:spPr>
          <a:xfrm rot="18587907">
            <a:off x="6101447" y="1033490"/>
            <a:ext cx="216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Empty vector control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893ACC7-ACD2-47EF-8EF3-EED03AA585D6}"/>
              </a:ext>
            </a:extLst>
          </p:cNvPr>
          <p:cNvSpPr txBox="1"/>
          <p:nvPr/>
        </p:nvSpPr>
        <p:spPr>
          <a:xfrm rot="18587907">
            <a:off x="6468797" y="1023172"/>
            <a:ext cx="216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RNY5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WT plasmid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C1B6940-64BB-421C-9138-30C7573F5373}"/>
              </a:ext>
            </a:extLst>
          </p:cNvPr>
          <p:cNvSpPr txBox="1"/>
          <p:nvPr/>
        </p:nvSpPr>
        <p:spPr>
          <a:xfrm rot="18587907">
            <a:off x="6781676" y="1032850"/>
            <a:ext cx="216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1 plasmid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7E270A4-76B9-4B31-9C7A-A2E2E3E2C30E}"/>
              </a:ext>
            </a:extLst>
          </p:cNvPr>
          <p:cNvSpPr txBox="1"/>
          <p:nvPr/>
        </p:nvSpPr>
        <p:spPr>
          <a:xfrm rot="18587907">
            <a:off x="7115874" y="1027241"/>
            <a:ext cx="216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2 plasmid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07A24ED-6CEE-4473-A73D-2D1AFD55C3A0}"/>
              </a:ext>
            </a:extLst>
          </p:cNvPr>
          <p:cNvSpPr txBox="1"/>
          <p:nvPr/>
        </p:nvSpPr>
        <p:spPr>
          <a:xfrm rot="18587907">
            <a:off x="7362564" y="907586"/>
            <a:ext cx="2494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RNY5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WT plasmid &amp; ST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EC293E4-C255-46B2-A6FF-97A49DC9D4C0}"/>
              </a:ext>
            </a:extLst>
          </p:cNvPr>
          <p:cNvSpPr txBox="1"/>
          <p:nvPr/>
        </p:nvSpPr>
        <p:spPr>
          <a:xfrm rot="18587907">
            <a:off x="7687378" y="897618"/>
            <a:ext cx="2494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1 plasmid &amp; ST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3E22A82-B937-4431-AF96-A9EA0ADD898F}"/>
              </a:ext>
            </a:extLst>
          </p:cNvPr>
          <p:cNvSpPr txBox="1"/>
          <p:nvPr/>
        </p:nvSpPr>
        <p:spPr>
          <a:xfrm rot="18587907">
            <a:off x="8005557" y="897174"/>
            <a:ext cx="2494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2 plasmid &amp; ST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7181E38-ED55-47BB-B63E-A63F02D1D092}"/>
              </a:ext>
            </a:extLst>
          </p:cNvPr>
          <p:cNvSpPr txBox="1"/>
          <p:nvPr/>
        </p:nvSpPr>
        <p:spPr>
          <a:xfrm>
            <a:off x="5699281" y="0"/>
            <a:ext cx="241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2" name="Grafik 3">
            <a:extLst>
              <a:ext uri="{FF2B5EF4-FFF2-40B4-BE49-F238E27FC236}">
                <a16:creationId xmlns:a16="http://schemas.microsoft.com/office/drawing/2014/main" id="{45626BBD-DD2C-4FFB-91F7-91A50FC1FA1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422" y="2574840"/>
            <a:ext cx="4324794" cy="4034624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3A98D669-2EF8-4DF7-8BEC-E8A2C24F2F45}"/>
              </a:ext>
            </a:extLst>
          </p:cNvPr>
          <p:cNvSpPr txBox="1"/>
          <p:nvPr/>
        </p:nvSpPr>
        <p:spPr>
          <a:xfrm>
            <a:off x="-3626" y="2567059"/>
            <a:ext cx="241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43406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1</TotalTime>
  <Words>607</Words>
  <Application>Microsoft Office PowerPoint</Application>
  <PresentationFormat>Custom</PresentationFormat>
  <Paragraphs>8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East Ang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ll Green (MED - Staff)</dc:creator>
  <cp:lastModifiedBy>Darrell Green (MED - Staff)</cp:lastModifiedBy>
  <cp:revision>78</cp:revision>
  <cp:lastPrinted>2021-03-11T17:55:10Z</cp:lastPrinted>
  <dcterms:created xsi:type="dcterms:W3CDTF">2021-02-23T11:21:13Z</dcterms:created>
  <dcterms:modified xsi:type="dcterms:W3CDTF">2022-02-14T13:23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1099147399</vt:i4>
  </property>
  <property fmtid="{D5CDD505-2E9C-101B-9397-08002B2CF9AE}" pid="3" name="_NewReviewCycle">
    <vt:lpwstr/>
  </property>
  <property fmtid="{D5CDD505-2E9C-101B-9397-08002B2CF9AE}" pid="4" name="_EmailSubject">
    <vt:lpwstr>RNA Biology - Manuscript ID KRNB-2021-0491R3</vt:lpwstr>
  </property>
  <property fmtid="{D5CDD505-2E9C-101B-9397-08002B2CF9AE}" pid="5" name="_AuthorEmail">
    <vt:lpwstr>D.Green@uea.ac.uk</vt:lpwstr>
  </property>
  <property fmtid="{D5CDD505-2E9C-101B-9397-08002B2CF9AE}" pid="6" name="_AuthorEmailDisplayName">
    <vt:lpwstr>Darrell Green (MED - Staff)</vt:lpwstr>
  </property>
  <property fmtid="{D5CDD505-2E9C-101B-9397-08002B2CF9AE}" pid="7" name="_PreviousAdHocReviewCycleID">
    <vt:i4>687273966</vt:i4>
  </property>
</Properties>
</file>